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4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5" autoAdjust="0"/>
    <p:restoredTop sz="90812" autoAdjust="0"/>
  </p:normalViewPr>
  <p:slideViewPr>
    <p:cSldViewPr snapToGrid="0">
      <p:cViewPr varScale="1">
        <p:scale>
          <a:sx n="78" d="100"/>
          <a:sy n="78" d="100"/>
        </p:scale>
        <p:origin x="432" y="6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456582-0C56-4458-9F48-59CFE8C3FA5E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0B534D-B4F2-4703-A171-D47E1F4E1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439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1.</a:t>
            </a:r>
            <a:r>
              <a:rPr kumimoji="1" lang="ja-JP" altLang="en-US" dirty="0"/>
              <a:t> </a:t>
            </a:r>
            <a:r>
              <a:rPr lang="en-US" altLang="ja-JP" dirty="0"/>
              <a:t>Survey flow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B534D-B4F2-4703-A171-D47E1F4E1EF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3612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02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063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922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51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727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539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3885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620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673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968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572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6E703-F818-4DA6-957B-D8768D34DBAF}" type="datetimeFigureOut">
              <a:rPr kumimoji="1" lang="ja-JP" altLang="en-US" smtClean="0"/>
              <a:t>2020/5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8AB4C-5057-4B45-B96C-A549A87037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7080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955584A-42D1-4C01-8C64-70D2650A83B8}"/>
              </a:ext>
            </a:extLst>
          </p:cNvPr>
          <p:cNvSpPr txBox="1"/>
          <p:nvPr/>
        </p:nvSpPr>
        <p:spPr>
          <a:xfrm>
            <a:off x="641787" y="566182"/>
            <a:ext cx="786042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We checked via a screening question for the existence of daughters, living with mother, who were of HPV vaccine target age (12-16). For respondents meeting these requirements, we asked the daughter’s age and HPV vaccination history.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 We extracted a group of eligible respondents who were representative of the overall responders, according to data collected to monitor registered survey panel members.</a:t>
            </a:r>
            <a:endParaRPr kumimoji="1" lang="ja-JP" altLang="en-US" sz="1400" dirty="0">
              <a:solidFill>
                <a:srgbClr val="FF0000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83F662-1E78-484B-8441-AAE7D8C6605D}"/>
              </a:ext>
            </a:extLst>
          </p:cNvPr>
          <p:cNvSpPr txBox="1"/>
          <p:nvPr/>
        </p:nvSpPr>
        <p:spPr>
          <a:xfrm>
            <a:off x="562647" y="2232306"/>
            <a:ext cx="80133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he main survey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 We asked several questions related to cervical cancer and the HPV vaccine.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 We asked what was the intention of the mothers to inoculate their daughters: </a:t>
            </a:r>
          </a:p>
          <a:p>
            <a:r>
              <a:rPr kumimoji="1" lang="ja-JP" altLang="en-US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1) Under the current circumstances, (2) If the MHLW restarted their vaccine recommendation.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C374D8F9-F443-4344-BEC9-B5BAAF30D595}"/>
              </a:ext>
            </a:extLst>
          </p:cNvPr>
          <p:cNvCxnSpPr>
            <a:cxnSpLocks/>
          </p:cNvCxnSpPr>
          <p:nvPr/>
        </p:nvCxnSpPr>
        <p:spPr>
          <a:xfrm>
            <a:off x="4569297" y="1826139"/>
            <a:ext cx="0" cy="3600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A4CB0A54-0FEF-4E9F-A73A-4F0771843EE9}"/>
              </a:ext>
            </a:extLst>
          </p:cNvPr>
          <p:cNvSpPr/>
          <p:nvPr/>
        </p:nvSpPr>
        <p:spPr>
          <a:xfrm>
            <a:off x="641787" y="252420"/>
            <a:ext cx="743876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ja-JP" sz="1600" b="1" u="sng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,545 mothers had HPV-unvaccinated daughters aged 12–16</a:t>
            </a:r>
            <a:endParaRPr lang="ja-JP" altLang="en-US" sz="1600" b="1" u="sng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EB3DB317-5B8A-43CD-9BA2-E29E9387C983}"/>
              </a:ext>
            </a:extLst>
          </p:cNvPr>
          <p:cNvSpPr/>
          <p:nvPr/>
        </p:nvSpPr>
        <p:spPr>
          <a:xfrm>
            <a:off x="494275" y="162013"/>
            <a:ext cx="8150047" cy="166412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5D59942A-A674-4FAD-B9A4-1F5B0E5E5E19}"/>
              </a:ext>
            </a:extLst>
          </p:cNvPr>
          <p:cNvSpPr/>
          <p:nvPr/>
        </p:nvSpPr>
        <p:spPr>
          <a:xfrm>
            <a:off x="494275" y="2197794"/>
            <a:ext cx="8150047" cy="102313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BF66C617-E099-46A0-AED9-C2A39CBA519B}"/>
              </a:ext>
            </a:extLst>
          </p:cNvPr>
          <p:cNvSpPr/>
          <p:nvPr/>
        </p:nvSpPr>
        <p:spPr>
          <a:xfrm>
            <a:off x="3312000" y="4091171"/>
            <a:ext cx="2520000" cy="10585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805C140-66FD-4718-B1E0-DA4AA1BABA98}"/>
              </a:ext>
            </a:extLst>
          </p:cNvPr>
          <p:cNvSpPr txBox="1"/>
          <p:nvPr/>
        </p:nvSpPr>
        <p:spPr>
          <a:xfrm>
            <a:off x="562647" y="3568209"/>
            <a:ext cx="80133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ntervention with leaflets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We randomly divided mothers into 3 groups and displayed one of 3 leaflet images on their screen.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44939BF-70A5-43BF-A713-57A026698311}"/>
              </a:ext>
            </a:extLst>
          </p:cNvPr>
          <p:cNvSpPr txBox="1"/>
          <p:nvPr/>
        </p:nvSpPr>
        <p:spPr>
          <a:xfrm>
            <a:off x="3312000" y="4143381"/>
            <a:ext cx="2520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roup 2: A leaflet we created that could still be used while under MHLW’s suspension of recommendation.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2417E76-04B6-427E-A6D8-253EAAF82D59}"/>
              </a:ext>
            </a:extLst>
          </p:cNvPr>
          <p:cNvSpPr txBox="1"/>
          <p:nvPr/>
        </p:nvSpPr>
        <p:spPr>
          <a:xfrm>
            <a:off x="562647" y="5532263"/>
            <a:ext cx="801330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Questions after intervention with leaflets  </a:t>
            </a:r>
          </a:p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- We asked again the intention of the mothers to inoculate their daughters: </a:t>
            </a:r>
          </a:p>
          <a:p>
            <a:r>
              <a:rPr kumimoji="1" lang="ja-JP" altLang="en-US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　</a:t>
            </a:r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1) Under the current circumstances, (2) If the MHLW restarted their vaccine recommendation.</a:t>
            </a: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988BDEE5-F84F-44FC-9D86-A1BA55238809}"/>
              </a:ext>
            </a:extLst>
          </p:cNvPr>
          <p:cNvSpPr/>
          <p:nvPr/>
        </p:nvSpPr>
        <p:spPr>
          <a:xfrm>
            <a:off x="494275" y="5516240"/>
            <a:ext cx="8150047" cy="7707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7E57B4FC-D86D-489D-966A-3557DD782A7C}"/>
              </a:ext>
            </a:extLst>
          </p:cNvPr>
          <p:cNvCxnSpPr>
            <a:cxnSpLocks/>
          </p:cNvCxnSpPr>
          <p:nvPr/>
        </p:nvCxnSpPr>
        <p:spPr>
          <a:xfrm>
            <a:off x="4569297" y="3220924"/>
            <a:ext cx="0" cy="3600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40A3F8B3-DEE4-4862-B460-42823FCF42D1}"/>
              </a:ext>
            </a:extLst>
          </p:cNvPr>
          <p:cNvCxnSpPr>
            <a:cxnSpLocks/>
          </p:cNvCxnSpPr>
          <p:nvPr/>
        </p:nvCxnSpPr>
        <p:spPr>
          <a:xfrm>
            <a:off x="4569297" y="5149698"/>
            <a:ext cx="0" cy="3600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1A56E3D5-13BB-48BF-8096-B2E722CA46E2}"/>
              </a:ext>
            </a:extLst>
          </p:cNvPr>
          <p:cNvSpPr/>
          <p:nvPr/>
        </p:nvSpPr>
        <p:spPr>
          <a:xfrm>
            <a:off x="647194" y="4091171"/>
            <a:ext cx="2520000" cy="10585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CE4263D-0682-45F9-9725-761111DEE85F}"/>
              </a:ext>
            </a:extLst>
          </p:cNvPr>
          <p:cNvSpPr txBox="1"/>
          <p:nvPr/>
        </p:nvSpPr>
        <p:spPr>
          <a:xfrm>
            <a:off x="681382" y="4143381"/>
            <a:ext cx="2451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roup 1: A leaflet distributed by the MHLW.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9D1F5F21-D7B8-469F-8B61-4C7BAC59FFC6}"/>
              </a:ext>
            </a:extLst>
          </p:cNvPr>
          <p:cNvCxnSpPr>
            <a:cxnSpLocks/>
          </p:cNvCxnSpPr>
          <p:nvPr/>
        </p:nvCxnSpPr>
        <p:spPr>
          <a:xfrm>
            <a:off x="1904491" y="5149698"/>
            <a:ext cx="0" cy="3600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1A259204-E87A-4169-80AD-2B5088807E15}"/>
              </a:ext>
            </a:extLst>
          </p:cNvPr>
          <p:cNvSpPr/>
          <p:nvPr/>
        </p:nvSpPr>
        <p:spPr>
          <a:xfrm>
            <a:off x="5976806" y="4091171"/>
            <a:ext cx="2520000" cy="105852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2E1B7B2-BB7D-499E-8C34-666DC4D9677C}"/>
              </a:ext>
            </a:extLst>
          </p:cNvPr>
          <p:cNvSpPr txBox="1"/>
          <p:nvPr/>
        </p:nvSpPr>
        <p:spPr>
          <a:xfrm>
            <a:off x="6010994" y="4143381"/>
            <a:ext cx="24516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roup 3: Intervention by a leaflet we created that was considered to be a positive recommendation.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A94D332C-23A0-4B0F-81DD-F8FC980B6117}"/>
              </a:ext>
            </a:extLst>
          </p:cNvPr>
          <p:cNvCxnSpPr>
            <a:cxnSpLocks/>
          </p:cNvCxnSpPr>
          <p:nvPr/>
        </p:nvCxnSpPr>
        <p:spPr>
          <a:xfrm>
            <a:off x="7234103" y="5149698"/>
            <a:ext cx="0" cy="36000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64745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87</TotalTime>
  <Words>241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sakauniv byouri</dc:creator>
  <cp:lastModifiedBy>osakauniv byouri</cp:lastModifiedBy>
  <cp:revision>621</cp:revision>
  <dcterms:created xsi:type="dcterms:W3CDTF">2020-04-13T08:23:38Z</dcterms:created>
  <dcterms:modified xsi:type="dcterms:W3CDTF">2020-05-22T07:10:21Z</dcterms:modified>
</cp:coreProperties>
</file>